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6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772816" y="2987821"/>
            <a:ext cx="27753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Additional file </a:t>
            </a:r>
            <a:r>
              <a:rPr lang="en-AU" b="1" dirty="0" smtClean="0"/>
              <a:t>12: Table S3 </a:t>
            </a:r>
            <a:endParaRPr lang="en-AU" b="1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332656" y="971600"/>
          <a:ext cx="6072340" cy="1842474"/>
        </p:xfrm>
        <a:graphic>
          <a:graphicData uri="http://schemas.openxmlformats.org/drawingml/2006/table">
            <a:tbl>
              <a:tblPr/>
              <a:tblGrid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  <a:gridCol w="607234"/>
              </a:tblGrid>
              <a:tr h="371822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AU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ble </a:t>
                      </a:r>
                      <a:r>
                        <a:rPr lang="en-AU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3</a:t>
                      </a:r>
                      <a:r>
                        <a:rPr lang="en-A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emical composition of ROC </a:t>
                      </a:r>
                      <a:r>
                        <a:rPr lang="en-A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ream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19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4</a:t>
                      </a:r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3</a:t>
                      </a:r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</a:t>
                      </a:r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,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i,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n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b,       mg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886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5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2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74284"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33582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4</TotalTime>
  <Words>49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36:26Z</dcterms:modified>
</cp:coreProperties>
</file>